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72" userDrawn="1">
          <p15:clr>
            <a:srgbClr val="A4A3A4"/>
          </p15:clr>
        </p15:guide>
        <p15:guide id="2" pos="48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68" d="100"/>
          <a:sy n="68" d="100"/>
        </p:scale>
        <p:origin x="792" y="60"/>
      </p:cViewPr>
      <p:guideLst>
        <p:guide orient="horz" pos="3672"/>
        <p:guide pos="48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119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973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100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979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32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933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17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84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065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4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301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006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User\Desktop\Hasan_Vibrio\fwdallfiguresmahmudulhasan\Supplementary Figure 3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0413" y="-4763"/>
            <a:ext cx="5640704" cy="631100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1571625" y="6306243"/>
            <a:ext cx="932973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 Fig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condary structure prediction of constructed vaccine protein V1 using PESIPRED server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9997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</TotalTime>
  <Words>1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athish</cp:lastModifiedBy>
  <cp:revision>20</cp:revision>
  <dcterms:created xsi:type="dcterms:W3CDTF">2020-03-31T14:28:06Z</dcterms:created>
  <dcterms:modified xsi:type="dcterms:W3CDTF">2020-07-30T10:13:27Z</dcterms:modified>
</cp:coreProperties>
</file>